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2" d="100"/>
          <a:sy n="62" d="100"/>
        </p:scale>
        <p:origin x="86" y="34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838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146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682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834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70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69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941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121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516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82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34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C7010A-544D-410D-83D9-FDC1B1ECF28C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AB774E-8C9D-459E-8301-ECBF3CA6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500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64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r="680"/>
          <a:stretch/>
        </p:blipFill>
        <p:spPr>
          <a:xfrm>
            <a:off x="8328482" y="1418256"/>
            <a:ext cx="3495218" cy="3546311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-1" r="874"/>
          <a:stretch/>
        </p:blipFill>
        <p:spPr>
          <a:xfrm>
            <a:off x="287487" y="1377340"/>
            <a:ext cx="3540802" cy="3551338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r="426"/>
          <a:stretch/>
        </p:blipFill>
        <p:spPr>
          <a:xfrm>
            <a:off x="4306443" y="1369720"/>
            <a:ext cx="3557397" cy="357960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8397074">
            <a:off x="115218" y="5081576"/>
            <a:ext cx="5405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8397074">
            <a:off x="74611" y="5271376"/>
            <a:ext cx="10374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eruloyl Ami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8397074">
            <a:off x="616469" y="5198001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etami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397074">
            <a:off x="922961" y="5214346"/>
            <a:ext cx="8531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erulic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ci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8397074">
            <a:off x="1603958" y="5047417"/>
            <a:ext cx="4635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MF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8397074">
            <a:off x="2227060" y="5114753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8397074">
            <a:off x="2345113" y="5181616"/>
            <a:ext cx="8034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Coumari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8397074">
            <a:off x="2417204" y="5327881"/>
            <a:ext cx="10919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PDX + All HT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8397074">
            <a:off x="2808075" y="5315652"/>
            <a:ext cx="1083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odium Acet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8397074">
            <a:off x="6917470" y="5088455"/>
            <a:ext cx="5405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8397074">
            <a:off x="6232772" y="5121632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8397074">
            <a:off x="6135607" y="5322531"/>
            <a:ext cx="1083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odium Acet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8397074">
            <a:off x="10960754" y="5125300"/>
            <a:ext cx="5405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8397074">
            <a:off x="8843630" y="5296009"/>
            <a:ext cx="10374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eruloyl Ami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8397074">
            <a:off x="10365080" y="5238979"/>
            <a:ext cx="8531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erulic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ci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8397074">
            <a:off x="9970510" y="5107392"/>
            <a:ext cx="4635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MF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8397074">
            <a:off x="9128534" y="5340285"/>
            <a:ext cx="1083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odium Acet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838013" y="960551"/>
            <a:ext cx="2177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ximum growth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t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µ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9423552" y="1435145"/>
            <a:ext cx="1027034" cy="9910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/>
          <p:cNvSpPr/>
          <p:nvPr/>
        </p:nvSpPr>
        <p:spPr>
          <a:xfrm>
            <a:off x="5390066" y="1415559"/>
            <a:ext cx="1027034" cy="9910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/>
          <p:cNvSpPr/>
          <p:nvPr/>
        </p:nvSpPr>
        <p:spPr>
          <a:xfrm>
            <a:off x="1358657" y="1439943"/>
            <a:ext cx="1027034" cy="9910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/>
          <p:cNvSpPr txBox="1"/>
          <p:nvPr/>
        </p:nvSpPr>
        <p:spPr>
          <a:xfrm>
            <a:off x="4883790" y="944488"/>
            <a:ext cx="23166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Maximum biomass (OD</a:t>
            </a:r>
            <a:r>
              <a:rPr lang="en-US" sz="1400" baseline="-25000" smtClean="0">
                <a:latin typeface="Arial" panose="020B0604020202020204" pitchFamily="34" charset="0"/>
                <a:cs typeface="Arial" panose="020B0604020202020204" pitchFamily="34" charset="0"/>
              </a:rPr>
              <a:t>595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9076733" y="936809"/>
            <a:ext cx="16962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aptation time (h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8397074">
            <a:off x="1350421" y="5366386"/>
            <a:ext cx="12009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umaroyl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mi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8397074">
            <a:off x="3951483" y="5188154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etami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8397074">
            <a:off x="3984693" y="5342237"/>
            <a:ext cx="12009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umaroyl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mi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8397074">
            <a:off x="4599360" y="5238730"/>
            <a:ext cx="8531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erulic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ci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8397074">
            <a:off x="5296164" y="5059622"/>
            <a:ext cx="4635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MF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8397074">
            <a:off x="5321054" y="5206001"/>
            <a:ext cx="8034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Coumari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8397074">
            <a:off x="5502006" y="5265531"/>
            <a:ext cx="10374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eruloyl Ami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Picture 6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462778" y="97013"/>
            <a:ext cx="1499950" cy="788788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 rot="18397074">
            <a:off x="7982628" y="5203390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etami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8397074">
            <a:off x="8320622" y="5187005"/>
            <a:ext cx="8034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Coumari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 rot="18397074">
            <a:off x="8880658" y="5117251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rot="18397074">
            <a:off x="9732389" y="5385512"/>
            <a:ext cx="12009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umaroyl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mi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25464" y="555628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244910" y="558196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8268809" y="561247"/>
            <a:ext cx="3706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8397074">
            <a:off x="6837548" y="5306730"/>
            <a:ext cx="10919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PDX + All HT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8397074">
            <a:off x="10876849" y="5319720"/>
            <a:ext cx="10919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PDX + All HT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9198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70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VE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12</cp:revision>
  <dcterms:created xsi:type="dcterms:W3CDTF">2016-06-10T17:34:12Z</dcterms:created>
  <dcterms:modified xsi:type="dcterms:W3CDTF">2017-01-30T16:23:48Z</dcterms:modified>
</cp:coreProperties>
</file>